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0432" y="3438232"/>
            <a:ext cx="508360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8 Fig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MMØ deficient in both cathepsin S and L have reduced MHC-II restricted presentation efficiencies of MOG antigen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MMØ derived from WT mice and mice deficient in both cathepsin S and L (Cat 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were examined for their ability to activate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pecific CD4+ T cells following incubation with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eptide (0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or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0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. Activation of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pecific 2D2 CD4+ T cells was determined by surface expression of CD69 after exposure to the pulsed and washed BMMØs.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Data represent 4 independent experime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ata presented as mean+/- SEM; significant differences (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unpaired students t-test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&lt;0.05) from the WT internal control are denoted by asterisks (*).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146" name="Picture 2" descr="C:\Users\Euan\Desktop\Euan's LAB NEW\Manuscripts\CAT EAE Manuscript\CAT BSL Paper\Prizm FIles\High Res pannels\S8 a peptide LS double KO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5812" y="807104"/>
            <a:ext cx="2270760" cy="1874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Euan\Desktop\Euan's LAB NEW\Manuscripts\CAT EAE Manuscript\CAT BSL Paper\Prizm FIles\High Res pannels\S8 b rmog LS double KO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8223" y="807104"/>
            <a:ext cx="2304288" cy="18745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20792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13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8:53Z</dcterms:modified>
</cp:coreProperties>
</file>